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89592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501907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68405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17477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10799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08135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257162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307403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46854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606349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41557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447729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49F301D2-850A-46AB-89B3-0376D821DBD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7155"/>
          <a:stretch/>
        </p:blipFill>
        <p:spPr>
          <a:xfrm>
            <a:off x="865545" y="148595"/>
            <a:ext cx="10447282" cy="631225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7C9DBD5-8F61-4565-8E6D-4F20F1DE4710}"/>
              </a:ext>
            </a:extLst>
          </p:cNvPr>
          <p:cNvSpPr txBox="1"/>
          <p:nvPr/>
        </p:nvSpPr>
        <p:spPr>
          <a:xfrm>
            <a:off x="343030" y="6261614"/>
            <a:ext cx="116948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firmation of the sequence of the </a:t>
            </a:r>
            <a:r>
              <a:rPr lang="en-US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nA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ene inserted in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cnA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by DNA sequencin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Pairwis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between the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cn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gene 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mlt360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the insert in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cn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as conducted using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lustalW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lgorithm. An asterisk (*) indicates identical sequences. The start (ATG) and stop (TGA) codons are in bold font.</a:t>
            </a:r>
          </a:p>
          <a:p>
            <a:endParaRPr lang="th-TH" sz="12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1402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688AE5E593A64468005895F2240B886" ma:contentTypeVersion="16" ma:contentTypeDescription="Create a new document." ma:contentTypeScope="" ma:versionID="5f7de0c1b92804a206beb029d94a6779">
  <xsd:schema xmlns:xsd="http://www.w3.org/2001/XMLSchema" xmlns:xs="http://www.w3.org/2001/XMLSchema" xmlns:p="http://schemas.microsoft.com/office/2006/metadata/properties" xmlns:ns3="df829e85-559d-4269-9e1e-f433727d8691" xmlns:ns4="25e4b857-6b1a-44b1-bf64-9765cd2c940a" targetNamespace="http://schemas.microsoft.com/office/2006/metadata/properties" ma:root="true" ma:fieldsID="08e5bddae88ddfb2b00b83bed636443d" ns3:_="" ns4:_="">
    <xsd:import namespace="df829e85-559d-4269-9e1e-f433727d8691"/>
    <xsd:import namespace="25e4b857-6b1a-44b1-bf64-9765cd2c940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f829e85-559d-4269-9e1e-f433727d869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9" nillable="true" ma:displayName="Location" ma:indexed="true" ma:internalName="MediaServiceLocation" ma:readOnly="true">
      <xsd:simpleType>
        <xsd:restriction base="dms:Text"/>
      </xsd:simpleType>
    </xsd:element>
    <xsd:element name="_activity" ma:index="20" nillable="true" ma:displayName="_activity" ma:hidden="true" ma:internalName="_activity">
      <xsd:simpleType>
        <xsd:restriction base="dms:Note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5e4b857-6b1a-44b1-bf64-9765cd2c940a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df829e85-559d-4269-9e1e-f433727d8691" xsi:nil="true"/>
  </documentManagement>
</p:properties>
</file>

<file path=customXml/itemProps1.xml><?xml version="1.0" encoding="utf-8"?>
<ds:datastoreItem xmlns:ds="http://schemas.openxmlformats.org/officeDocument/2006/customXml" ds:itemID="{34400E43-842D-490B-9C55-2564F1E2F08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80162BF-8FCF-42F6-A727-26FA1053A2C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f829e85-559d-4269-9e1e-f433727d8691"/>
    <ds:schemaRef ds:uri="25e4b857-6b1a-44b1-bf64-9765cd2c940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BAC8C19C-9AFF-4EF8-A5CC-48A1969E6167}">
  <ds:schemaRefs>
    <ds:schemaRef ds:uri="25e4b857-6b1a-44b1-bf64-9765cd2c940a"/>
    <ds:schemaRef ds:uri="http://purl.org/dc/dcmitype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df829e85-559d-4269-9e1e-f433727d8691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</TotalTime>
  <Words>6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rdia New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unyawee Dulyayangkul</dc:creator>
  <cp:lastModifiedBy>PaiboonV</cp:lastModifiedBy>
  <cp:revision>7</cp:revision>
  <dcterms:created xsi:type="dcterms:W3CDTF">2024-08-05T04:08:00Z</dcterms:created>
  <dcterms:modified xsi:type="dcterms:W3CDTF">2024-08-06T04:32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688AE5E593A64468005895F2240B886</vt:lpwstr>
  </property>
</Properties>
</file>